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74" d="100"/>
          <a:sy n="74" d="100"/>
        </p:scale>
        <p:origin x="4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8153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239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4976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6020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7620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6597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8122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5578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0857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8963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7899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CF290-7674-45A4-9E19-71BE29A992CB}" type="datetimeFigureOut">
              <a:rPr lang="en-GB" smtClean="0"/>
              <a:t>29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CE0CE-D5C0-45B1-865D-685241F8B8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2547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77315" y="896318"/>
            <a:ext cx="355869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TTAAAAAGTGTCGCTGCC---</a:t>
            </a:r>
            <a:endParaRPr lang="en-GB" sz="1600" dirty="0"/>
          </a:p>
        </p:txBody>
      </p:sp>
      <p:sp>
        <p:nvSpPr>
          <p:cNvPr id="3" name="Rectangle 2"/>
          <p:cNvSpPr/>
          <p:nvPr/>
        </p:nvSpPr>
        <p:spPr>
          <a:xfrm>
            <a:off x="1292930" y="3631823"/>
            <a:ext cx="756773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ATCAGTAGGTAGAGTGGCGCCCCGAGGTCTGCATCGTGTAGAGTGGTTGATCTCACGATGCAGACTCCTACTGCTGTCTAACGGGGGAGGGTATGCGGCGCTACACACTTAC</a:t>
            </a:r>
          </a:p>
        </p:txBody>
      </p:sp>
      <p:sp>
        <p:nvSpPr>
          <p:cNvPr id="4" name="Rectangle 3"/>
          <p:cNvSpPr/>
          <p:nvPr/>
        </p:nvSpPr>
        <p:spPr>
          <a:xfrm>
            <a:off x="1788041" y="1246430"/>
            <a:ext cx="284324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TTAAATTTCCGTAGCC---</a:t>
            </a:r>
            <a:endParaRPr lang="en-GB" sz="1600" dirty="0"/>
          </a:p>
        </p:txBody>
      </p:sp>
      <p:sp>
        <p:nvSpPr>
          <p:cNvPr id="5" name="Rectangle 4"/>
          <p:cNvSpPr/>
          <p:nvPr/>
        </p:nvSpPr>
        <p:spPr>
          <a:xfrm>
            <a:off x="1303051" y="4238309"/>
            <a:ext cx="667769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TGCGCGACCAATCTATGCACTTGGTAGCGGCAGCGGGAACACACTTAC</a:t>
            </a:r>
          </a:p>
        </p:txBody>
      </p:sp>
      <p:sp>
        <p:nvSpPr>
          <p:cNvPr id="6" name="Rectangle 5"/>
          <p:cNvSpPr/>
          <p:nvPr/>
        </p:nvSpPr>
        <p:spPr>
          <a:xfrm>
            <a:off x="1777315" y="1600785"/>
            <a:ext cx="407301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TTAAAAAGTGCGCCCTTAGCGAAG---</a:t>
            </a:r>
            <a:endParaRPr lang="en-GB" sz="1600" dirty="0"/>
          </a:p>
        </p:txBody>
      </p:sp>
      <p:sp>
        <p:nvSpPr>
          <p:cNvPr id="7" name="Rectangle 6"/>
          <p:cNvSpPr/>
          <p:nvPr/>
        </p:nvSpPr>
        <p:spPr>
          <a:xfrm>
            <a:off x="1331985" y="4651979"/>
            <a:ext cx="32993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ACGCAGCGACGGGAAGCACTTACACTTAC</a:t>
            </a:r>
            <a:endParaRPr lang="en-GB" sz="1400" dirty="0"/>
          </a:p>
        </p:txBody>
      </p:sp>
      <p:sp>
        <p:nvSpPr>
          <p:cNvPr id="8" name="Rectangle 7"/>
          <p:cNvSpPr/>
          <p:nvPr/>
        </p:nvSpPr>
        <p:spPr>
          <a:xfrm>
            <a:off x="1777315" y="1922933"/>
            <a:ext cx="330440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TTAAAAAATCCTTGAGTC--- </a:t>
            </a:r>
            <a:endParaRPr lang="en-GB" sz="1600" dirty="0"/>
          </a:p>
        </p:txBody>
      </p:sp>
      <p:sp>
        <p:nvSpPr>
          <p:cNvPr id="9" name="Rectangle 8"/>
          <p:cNvSpPr/>
          <p:nvPr/>
        </p:nvSpPr>
        <p:spPr>
          <a:xfrm>
            <a:off x="1342320" y="5160962"/>
            <a:ext cx="553791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CGCTTGTGACCGCGTGGTTAGGGGGGGATTTTACACTTAC</a:t>
            </a:r>
          </a:p>
        </p:txBody>
      </p:sp>
      <p:sp>
        <p:nvSpPr>
          <p:cNvPr id="10" name="Rectangle 9"/>
          <p:cNvSpPr/>
          <p:nvPr/>
        </p:nvSpPr>
        <p:spPr>
          <a:xfrm>
            <a:off x="1777315" y="2305014"/>
            <a:ext cx="315068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TTAAAATTATCCCTTGTC---</a:t>
            </a:r>
            <a:endParaRPr lang="en-GB" sz="1600" dirty="0"/>
          </a:p>
        </p:txBody>
      </p:sp>
      <p:sp>
        <p:nvSpPr>
          <p:cNvPr id="11" name="Rectangle 10"/>
          <p:cNvSpPr/>
          <p:nvPr/>
        </p:nvSpPr>
        <p:spPr>
          <a:xfrm>
            <a:off x="1331985" y="5507466"/>
            <a:ext cx="752867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TATGACCTCCACGAGCGGAAAATCCATCGTGTTGGATGGATGGAACGCCTAGATCGTTTTCTAGGGAGTGGGATAACAACTTAC</a:t>
            </a:r>
            <a:endParaRPr lang="en-GB" sz="1400" dirty="0"/>
          </a:p>
        </p:txBody>
      </p:sp>
      <p:sp>
        <p:nvSpPr>
          <p:cNvPr id="12" name="Rectangle 11"/>
          <p:cNvSpPr/>
          <p:nvPr/>
        </p:nvSpPr>
        <p:spPr>
          <a:xfrm>
            <a:off x="1777314" y="2641426"/>
            <a:ext cx="315068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TTAAAAAGTGTCGCTGCC---</a:t>
            </a:r>
            <a:endParaRPr lang="en-GB" sz="1600" dirty="0"/>
          </a:p>
        </p:txBody>
      </p:sp>
      <p:sp>
        <p:nvSpPr>
          <p:cNvPr id="13" name="Rectangle 12"/>
          <p:cNvSpPr/>
          <p:nvPr/>
        </p:nvSpPr>
        <p:spPr>
          <a:xfrm>
            <a:off x="1331025" y="6067022"/>
            <a:ext cx="752963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GGACAGTAGGTAGAGTGGCGCCCCAAGGTTTACGTCGTGCAGGGTGGTTGACCTCGCGGCGTAAATTCCCACTGCTGTATAACGGGGGAGGGTGCGCGATACTACACACTTA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672130" y="603268"/>
            <a:ext cx="4121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5’</a:t>
            </a:r>
            <a:endParaRPr lang="en-GB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1218948" y="3322363"/>
            <a:ext cx="4121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5’</a:t>
            </a:r>
            <a:endParaRPr lang="en-GB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4526605" y="613102"/>
            <a:ext cx="4121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3’</a:t>
            </a:r>
            <a:endParaRPr lang="en-GB" sz="1600" dirty="0"/>
          </a:p>
        </p:txBody>
      </p:sp>
      <p:sp>
        <p:nvSpPr>
          <p:cNvPr id="17" name="TextBox 16"/>
          <p:cNvSpPr txBox="1"/>
          <p:nvPr/>
        </p:nvSpPr>
        <p:spPr>
          <a:xfrm>
            <a:off x="8731877" y="3269073"/>
            <a:ext cx="4121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3’</a:t>
            </a:r>
            <a:endParaRPr lang="en-GB" sz="1600" dirty="0"/>
          </a:p>
        </p:txBody>
      </p:sp>
      <p:sp>
        <p:nvSpPr>
          <p:cNvPr id="18" name="TextBox 17"/>
          <p:cNvSpPr txBox="1"/>
          <p:nvPr/>
        </p:nvSpPr>
        <p:spPr>
          <a:xfrm>
            <a:off x="535017" y="889644"/>
            <a:ext cx="1113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 S10</a:t>
            </a:r>
            <a:endParaRPr lang="en-GB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535018" y="1232112"/>
            <a:ext cx="1113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 S3</a:t>
            </a:r>
            <a:endParaRPr lang="en-GB" sz="1600" dirty="0"/>
          </a:p>
        </p:txBody>
      </p:sp>
      <p:sp>
        <p:nvSpPr>
          <p:cNvPr id="20" name="TextBox 19"/>
          <p:cNvSpPr txBox="1"/>
          <p:nvPr/>
        </p:nvSpPr>
        <p:spPr>
          <a:xfrm>
            <a:off x="535018" y="1604323"/>
            <a:ext cx="1113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 S5</a:t>
            </a:r>
            <a:endParaRPr lang="en-GB" sz="1600" dirty="0"/>
          </a:p>
        </p:txBody>
      </p:sp>
      <p:sp>
        <p:nvSpPr>
          <p:cNvPr id="21" name="TextBox 20"/>
          <p:cNvSpPr txBox="1"/>
          <p:nvPr/>
        </p:nvSpPr>
        <p:spPr>
          <a:xfrm>
            <a:off x="524293" y="1945019"/>
            <a:ext cx="1113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 S8</a:t>
            </a:r>
            <a:endParaRPr lang="en-GB" sz="1600" dirty="0"/>
          </a:p>
        </p:txBody>
      </p:sp>
      <p:sp>
        <p:nvSpPr>
          <p:cNvPr id="22" name="TextBox 21"/>
          <p:cNvSpPr txBox="1"/>
          <p:nvPr/>
        </p:nvSpPr>
        <p:spPr>
          <a:xfrm>
            <a:off x="524291" y="2290672"/>
            <a:ext cx="12566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AHSV-4 S10</a:t>
            </a:r>
            <a:endParaRPr lang="en-GB" sz="1600" dirty="0"/>
          </a:p>
        </p:txBody>
      </p:sp>
      <p:sp>
        <p:nvSpPr>
          <p:cNvPr id="23" name="TextBox 22"/>
          <p:cNvSpPr txBox="1"/>
          <p:nvPr/>
        </p:nvSpPr>
        <p:spPr>
          <a:xfrm>
            <a:off x="535016" y="2627545"/>
            <a:ext cx="1245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0 S10</a:t>
            </a:r>
            <a:endParaRPr lang="en-GB" sz="1600" dirty="0"/>
          </a:p>
        </p:txBody>
      </p:sp>
      <p:sp>
        <p:nvSpPr>
          <p:cNvPr id="24" name="TextBox 23"/>
          <p:cNvSpPr txBox="1"/>
          <p:nvPr/>
        </p:nvSpPr>
        <p:spPr>
          <a:xfrm>
            <a:off x="545742" y="440053"/>
            <a:ext cx="888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5’ UTR</a:t>
            </a:r>
            <a:endParaRPr lang="en-GB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179069" y="3181303"/>
            <a:ext cx="888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3’ UTR</a:t>
            </a:r>
            <a:endParaRPr lang="en-GB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179069" y="3631163"/>
            <a:ext cx="1113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 S10</a:t>
            </a:r>
            <a:endParaRPr lang="en-GB" sz="1600" dirty="0"/>
          </a:p>
        </p:txBody>
      </p:sp>
      <p:sp>
        <p:nvSpPr>
          <p:cNvPr id="27" name="TextBox 26"/>
          <p:cNvSpPr txBox="1"/>
          <p:nvPr/>
        </p:nvSpPr>
        <p:spPr>
          <a:xfrm>
            <a:off x="179069" y="4222527"/>
            <a:ext cx="1113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 S3</a:t>
            </a:r>
            <a:endParaRPr lang="en-GB" sz="1600" dirty="0"/>
          </a:p>
        </p:txBody>
      </p:sp>
      <p:sp>
        <p:nvSpPr>
          <p:cNvPr id="28" name="TextBox 27"/>
          <p:cNvSpPr txBox="1"/>
          <p:nvPr/>
        </p:nvSpPr>
        <p:spPr>
          <a:xfrm>
            <a:off x="189191" y="4656049"/>
            <a:ext cx="1113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 S5</a:t>
            </a:r>
            <a:endParaRPr lang="en-GB" sz="1600" dirty="0"/>
          </a:p>
        </p:txBody>
      </p:sp>
      <p:sp>
        <p:nvSpPr>
          <p:cNvPr id="29" name="TextBox 28"/>
          <p:cNvSpPr txBox="1"/>
          <p:nvPr/>
        </p:nvSpPr>
        <p:spPr>
          <a:xfrm>
            <a:off x="179069" y="5104719"/>
            <a:ext cx="1113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 S8</a:t>
            </a:r>
            <a:endParaRPr lang="en-GB" sz="1600" dirty="0"/>
          </a:p>
        </p:txBody>
      </p:sp>
      <p:sp>
        <p:nvSpPr>
          <p:cNvPr id="30" name="TextBox 29"/>
          <p:cNvSpPr txBox="1"/>
          <p:nvPr/>
        </p:nvSpPr>
        <p:spPr>
          <a:xfrm>
            <a:off x="168343" y="5613288"/>
            <a:ext cx="12566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AHSV-4 S10</a:t>
            </a:r>
            <a:endParaRPr lang="en-GB" sz="1600" dirty="0"/>
          </a:p>
        </p:txBody>
      </p:sp>
      <p:sp>
        <p:nvSpPr>
          <p:cNvPr id="31" name="TextBox 30"/>
          <p:cNvSpPr txBox="1"/>
          <p:nvPr/>
        </p:nvSpPr>
        <p:spPr>
          <a:xfrm>
            <a:off x="179069" y="6067022"/>
            <a:ext cx="1245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TV-10 S10</a:t>
            </a:r>
            <a:endParaRPr lang="en-GB" sz="1600" dirty="0"/>
          </a:p>
        </p:txBody>
      </p:sp>
      <p:sp>
        <p:nvSpPr>
          <p:cNvPr id="32" name="TextBox 31"/>
          <p:cNvSpPr txBox="1"/>
          <p:nvPr/>
        </p:nvSpPr>
        <p:spPr>
          <a:xfrm>
            <a:off x="60195" y="70721"/>
            <a:ext cx="366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275033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195" y="70721"/>
            <a:ext cx="366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3" name="TextBox 2"/>
          <p:cNvSpPr txBox="1"/>
          <p:nvPr/>
        </p:nvSpPr>
        <p:spPr>
          <a:xfrm>
            <a:off x="219639" y="6301949"/>
            <a:ext cx="2742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Figure 1 </a:t>
            </a:r>
            <a:endParaRPr lang="en-GB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0968" y="989398"/>
            <a:ext cx="1867437" cy="246480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7658" y="687110"/>
            <a:ext cx="1778911" cy="258544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22202" y="3847000"/>
            <a:ext cx="1789124" cy="245494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98079" y="3913618"/>
            <a:ext cx="2075127" cy="256741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36120" y="778077"/>
            <a:ext cx="2287078" cy="265973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828799" y="326057"/>
            <a:ext cx="11333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TV-1 S10 (WT)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4338020" y="440053"/>
            <a:ext cx="1019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3/S10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6834375" y="440053"/>
            <a:ext cx="1019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5/S10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1706968" y="3649653"/>
            <a:ext cx="1019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8/S10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6611803" y="3705170"/>
            <a:ext cx="1529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4/B1 S10</a:t>
            </a:r>
            <a:endParaRPr lang="en-GB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6491" y="3889836"/>
            <a:ext cx="2238089" cy="2538176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3861838" y="3705170"/>
            <a:ext cx="1585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10/B1 S1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543576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5915" y="1416676"/>
            <a:ext cx="714777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Figure 1.  </a:t>
            </a:r>
            <a:r>
              <a:rPr lang="en-GB" dirty="0" smtClean="0"/>
              <a:t>A. The 5’ and 3’-UTR sequences of BTV-1 S10, S3, S5, S8, AHSV-4 S10 and BTV-10 S10. B. Secondary </a:t>
            </a:r>
            <a:r>
              <a:rPr lang="en-GB" dirty="0"/>
              <a:t>RNA structures </a:t>
            </a:r>
            <a:r>
              <a:rPr lang="en-GB" dirty="0" smtClean="0"/>
              <a:t>at the UTRs of wild-type BTV-1 S10 and chimeric S10 RNAs (S3/S10 to A4/B1 S10) are </a:t>
            </a:r>
            <a:r>
              <a:rPr lang="en-GB" dirty="0"/>
              <a:t>depicted as predicted using </a:t>
            </a:r>
            <a:r>
              <a:rPr lang="en-GB" dirty="0" err="1"/>
              <a:t>RNAfold</a:t>
            </a:r>
            <a:r>
              <a:rPr lang="en-GB" dirty="0"/>
              <a:t> prediction </a:t>
            </a:r>
            <a:r>
              <a:rPr lang="en-GB" dirty="0" smtClean="0"/>
              <a:t>software (minimum free energy (MFE) and partition function at 37°C, Turner model 1999)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17642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150</Words>
  <Application>Microsoft Office PowerPoint</Application>
  <PresentationFormat>On-screen Show (4:3)</PresentationFormat>
  <Paragraphs>4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TS</dc:creator>
  <cp:lastModifiedBy>ITS</cp:lastModifiedBy>
  <cp:revision>6</cp:revision>
  <dcterms:created xsi:type="dcterms:W3CDTF">2014-09-22T13:52:33Z</dcterms:created>
  <dcterms:modified xsi:type="dcterms:W3CDTF">2014-10-29T14:10:35Z</dcterms:modified>
</cp:coreProperties>
</file>